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4AE764-2774-4163-AD8A-0FF101BEC237}" v="8" dt="2023-06-20T16:29:42.9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55" autoAdjust="0"/>
    <p:restoredTop sz="94660"/>
  </p:normalViewPr>
  <p:slideViewPr>
    <p:cSldViewPr snapToGrid="0">
      <p:cViewPr varScale="1">
        <p:scale>
          <a:sx n="85" d="100"/>
          <a:sy n="85" d="100"/>
        </p:scale>
        <p:origin x="7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6937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1963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9976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2061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9060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1186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1456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5080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676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472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811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D3A76-A31B-46A0-AE43-6AEEB518B98E}" type="datetimeFigureOut">
              <a:rPr lang="fr-FR" smtClean="0"/>
              <a:t>07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7F84C-28BF-461D-B451-DC323FB34D8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1676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7">
            <a:extLst>
              <a:ext uri="{FF2B5EF4-FFF2-40B4-BE49-F238E27FC236}">
                <a16:creationId xmlns:a16="http://schemas.microsoft.com/office/drawing/2014/main" id="{A9374235-3249-6999-27A2-F6E75E7234D9}"/>
              </a:ext>
            </a:extLst>
          </p:cNvPr>
          <p:cNvSpPr txBox="1"/>
          <p:nvPr/>
        </p:nvSpPr>
        <p:spPr>
          <a:xfrm>
            <a:off x="164597" y="328043"/>
            <a:ext cx="35954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-figure supplement 1-sourc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l="10933" t="10040" r="6032" b="16931"/>
          <a:stretch/>
        </p:blipFill>
        <p:spPr>
          <a:xfrm>
            <a:off x="3982834" y="191178"/>
            <a:ext cx="2844800" cy="14097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A61DCD4-11F4-DCC2-1CB2-889590BBE9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270" b="5206"/>
          <a:stretch/>
        </p:blipFill>
        <p:spPr>
          <a:xfrm>
            <a:off x="419745" y="6297086"/>
            <a:ext cx="3381461" cy="102119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1460E41-B4CE-0664-B369-58190DEE533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042" b="6727"/>
          <a:stretch/>
        </p:blipFill>
        <p:spPr>
          <a:xfrm>
            <a:off x="407627" y="7331127"/>
            <a:ext cx="3392805" cy="102119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085FDD8-EECB-8D4D-5FB9-8DDCF622CA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621"/>
          <a:stretch/>
        </p:blipFill>
        <p:spPr>
          <a:xfrm>
            <a:off x="406452" y="8378257"/>
            <a:ext cx="3392805" cy="118012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B2D58E65-6FC3-04B4-3D46-5B8BE920130B}"/>
              </a:ext>
            </a:extLst>
          </p:cNvPr>
          <p:cNvSpPr/>
          <p:nvPr/>
        </p:nvSpPr>
        <p:spPr>
          <a:xfrm>
            <a:off x="2442714" y="6494712"/>
            <a:ext cx="1356543" cy="4953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2BD35DE-5011-D2EB-1A6D-DD830320B5C4}"/>
              </a:ext>
            </a:extLst>
          </p:cNvPr>
          <p:cNvSpPr txBox="1"/>
          <p:nvPr/>
        </p:nvSpPr>
        <p:spPr>
          <a:xfrm rot="19800000">
            <a:off x="1604737" y="5874724"/>
            <a:ext cx="8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D96524-8066-6C8A-BA3E-679AE100A57B}"/>
              </a:ext>
            </a:extLst>
          </p:cNvPr>
          <p:cNvSpPr txBox="1"/>
          <p:nvPr/>
        </p:nvSpPr>
        <p:spPr>
          <a:xfrm rot="19800000">
            <a:off x="2076296" y="5872877"/>
            <a:ext cx="835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7D94D0-FB35-257E-A394-04A87F9FF262}"/>
              </a:ext>
            </a:extLst>
          </p:cNvPr>
          <p:cNvSpPr txBox="1"/>
          <p:nvPr/>
        </p:nvSpPr>
        <p:spPr>
          <a:xfrm rot="19800000">
            <a:off x="1138458" y="5885094"/>
            <a:ext cx="7867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CBDC58-D377-2912-CEBA-448FB6228861}"/>
              </a:ext>
            </a:extLst>
          </p:cNvPr>
          <p:cNvSpPr txBox="1"/>
          <p:nvPr/>
        </p:nvSpPr>
        <p:spPr>
          <a:xfrm>
            <a:off x="1205963" y="5568704"/>
            <a:ext cx="11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licate 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5F46AE5-0D06-B5BE-7C8A-975F6720BF91}"/>
              </a:ext>
            </a:extLst>
          </p:cNvPr>
          <p:cNvSpPr txBox="1"/>
          <p:nvPr/>
        </p:nvSpPr>
        <p:spPr>
          <a:xfrm rot="19800000">
            <a:off x="3028218" y="5874724"/>
            <a:ext cx="8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25BD233-D0AB-7839-4EF6-C3F3AC13D52D}"/>
              </a:ext>
            </a:extLst>
          </p:cNvPr>
          <p:cNvSpPr txBox="1"/>
          <p:nvPr/>
        </p:nvSpPr>
        <p:spPr>
          <a:xfrm rot="19800000">
            <a:off x="3499777" y="5872877"/>
            <a:ext cx="835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C2C8D7-F35E-9CA7-12F3-3150DB42F39B}"/>
              </a:ext>
            </a:extLst>
          </p:cNvPr>
          <p:cNvSpPr txBox="1"/>
          <p:nvPr/>
        </p:nvSpPr>
        <p:spPr>
          <a:xfrm rot="19800000">
            <a:off x="2561939" y="5885094"/>
            <a:ext cx="7867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370BFF-ACF5-04FC-3563-02B38DB0990A}"/>
              </a:ext>
            </a:extLst>
          </p:cNvPr>
          <p:cNvSpPr txBox="1"/>
          <p:nvPr/>
        </p:nvSpPr>
        <p:spPr>
          <a:xfrm>
            <a:off x="2631377" y="5568704"/>
            <a:ext cx="11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licate 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3795448" y="6605618"/>
            <a:ext cx="451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B7A38F4-AD02-AB57-4A87-45F1740F2344}"/>
              </a:ext>
            </a:extLst>
          </p:cNvPr>
          <p:cNvSpPr txBox="1"/>
          <p:nvPr/>
        </p:nvSpPr>
        <p:spPr>
          <a:xfrm>
            <a:off x="3795448" y="7720895"/>
            <a:ext cx="694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C849CD5-640E-39C9-7F88-9A54CA6EF0AC}"/>
              </a:ext>
            </a:extLst>
          </p:cNvPr>
          <p:cNvSpPr txBox="1"/>
          <p:nvPr/>
        </p:nvSpPr>
        <p:spPr>
          <a:xfrm>
            <a:off x="3795448" y="8678364"/>
            <a:ext cx="694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M6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5883B7-4BA2-85DE-E5FC-8438CD474A54}"/>
              </a:ext>
            </a:extLst>
          </p:cNvPr>
          <p:cNvSpPr txBox="1"/>
          <p:nvPr/>
        </p:nvSpPr>
        <p:spPr>
          <a:xfrm>
            <a:off x="4648570" y="7020080"/>
            <a:ext cx="210778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se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performed on samples from the conditioned medium of </a:t>
            </a:r>
            <a:r>
              <a:rPr lang="en-US" sz="105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siSAM68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.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s HSP90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SAM68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s are not detectable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secreted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action.</a:t>
            </a:r>
            <a:endParaRPr 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24B510D3-9101-957B-6AF5-FCECE2CADE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6452" y="2067434"/>
            <a:ext cx="3661117" cy="100179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E3F2479E-D915-AE97-0DB7-3A1F62DBA5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7212" y="3125569"/>
            <a:ext cx="3669340" cy="1004048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532A8B3A-7F0B-D9AC-359B-3FEB0DB243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7212" y="4170701"/>
            <a:ext cx="3669340" cy="100404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0DD67C50-354E-3D28-FEF6-AA382549CEF5}"/>
              </a:ext>
            </a:extLst>
          </p:cNvPr>
          <p:cNvSpPr txBox="1"/>
          <p:nvPr/>
        </p:nvSpPr>
        <p:spPr>
          <a:xfrm rot="19800000">
            <a:off x="1540240" y="1676387"/>
            <a:ext cx="8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1B3A790-D601-8237-F623-B825BBD0579A}"/>
              </a:ext>
            </a:extLst>
          </p:cNvPr>
          <p:cNvSpPr txBox="1"/>
          <p:nvPr/>
        </p:nvSpPr>
        <p:spPr>
          <a:xfrm rot="19800000">
            <a:off x="2011799" y="1674540"/>
            <a:ext cx="835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D65644A-505B-22A0-330B-233882BA1E67}"/>
              </a:ext>
            </a:extLst>
          </p:cNvPr>
          <p:cNvSpPr txBox="1"/>
          <p:nvPr/>
        </p:nvSpPr>
        <p:spPr>
          <a:xfrm rot="19800000">
            <a:off x="1073961" y="1686757"/>
            <a:ext cx="7867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1F5DEE2-7AFA-A9A4-9FA4-CD923171ADA2}"/>
              </a:ext>
            </a:extLst>
          </p:cNvPr>
          <p:cNvSpPr txBox="1"/>
          <p:nvPr/>
        </p:nvSpPr>
        <p:spPr>
          <a:xfrm>
            <a:off x="1130697" y="1333298"/>
            <a:ext cx="11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licate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8E27ED7-F180-6B59-EE42-0E867BB1E520}"/>
              </a:ext>
            </a:extLst>
          </p:cNvPr>
          <p:cNvSpPr txBox="1"/>
          <p:nvPr/>
        </p:nvSpPr>
        <p:spPr>
          <a:xfrm rot="19800000">
            <a:off x="2963720" y="1676387"/>
            <a:ext cx="82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8725FF3-277B-E76B-C49A-86FEA85A0971}"/>
              </a:ext>
            </a:extLst>
          </p:cNvPr>
          <p:cNvSpPr txBox="1"/>
          <p:nvPr/>
        </p:nvSpPr>
        <p:spPr>
          <a:xfrm rot="19800000">
            <a:off x="3435279" y="1674540"/>
            <a:ext cx="835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S68-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521168-D85F-B6E9-4A5D-E8E54B1D9CFD}"/>
              </a:ext>
            </a:extLst>
          </p:cNvPr>
          <p:cNvSpPr txBox="1"/>
          <p:nvPr/>
        </p:nvSpPr>
        <p:spPr>
          <a:xfrm rot="19800000">
            <a:off x="2497441" y="1686757"/>
            <a:ext cx="7867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916170F-7532-893D-694B-3DCA4C192F6F}"/>
              </a:ext>
            </a:extLst>
          </p:cNvPr>
          <p:cNvSpPr txBox="1"/>
          <p:nvPr/>
        </p:nvSpPr>
        <p:spPr>
          <a:xfrm>
            <a:off x="2554178" y="1333298"/>
            <a:ext cx="1150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licate 2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25CED3B-D47A-7067-EEEB-84B98A30F9A8}"/>
              </a:ext>
            </a:extLst>
          </p:cNvPr>
          <p:cNvSpPr/>
          <p:nvPr/>
        </p:nvSpPr>
        <p:spPr>
          <a:xfrm>
            <a:off x="2378411" y="2234018"/>
            <a:ext cx="1474686" cy="5261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434C4A3-10F5-B57F-18A7-828B36C0CE5D}"/>
              </a:ext>
            </a:extLst>
          </p:cNvPr>
          <p:cNvSpPr txBox="1"/>
          <p:nvPr/>
        </p:nvSpPr>
        <p:spPr>
          <a:xfrm>
            <a:off x="4753360" y="3397412"/>
            <a:ext cx="1853831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se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performed on samples from the ECM fraction assembled on plates after gentle removal of </a:t>
            </a:r>
            <a:r>
              <a:rPr lang="en-US" sz="105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siSAM68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. Thus, HSP90 and SAM68 proteins are not, or barely, detectable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CM </a:t>
            </a:r>
            <a:r>
              <a:rPr 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action </a:t>
            </a:r>
            <a:r>
              <a:rPr lang="en-US" sz="105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B7A38F4-AD02-AB57-4A87-45F1740F2344}"/>
              </a:ext>
            </a:extLst>
          </p:cNvPr>
          <p:cNvSpPr txBox="1"/>
          <p:nvPr/>
        </p:nvSpPr>
        <p:spPr>
          <a:xfrm>
            <a:off x="4059356" y="3629077"/>
            <a:ext cx="694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C849CD5-640E-39C9-7F88-9A54CA6EF0AC}"/>
              </a:ext>
            </a:extLst>
          </p:cNvPr>
          <p:cNvSpPr txBox="1"/>
          <p:nvPr/>
        </p:nvSpPr>
        <p:spPr>
          <a:xfrm>
            <a:off x="4059356" y="4319846"/>
            <a:ext cx="694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M6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4059356" y="2380423"/>
            <a:ext cx="451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397212" y="1805345"/>
            <a:ext cx="518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-125171" y="2306417"/>
            <a:ext cx="606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00 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698122" y="6075213"/>
            <a:ext cx="518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ABB9D4B-54B3-E8B6-1346-6FAC022AD08A}"/>
              </a:ext>
            </a:extLst>
          </p:cNvPr>
          <p:cNvSpPr txBox="1"/>
          <p:nvPr/>
        </p:nvSpPr>
        <p:spPr>
          <a:xfrm>
            <a:off x="-151640" y="6576285"/>
            <a:ext cx="606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00 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23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107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obber</dc:creator>
  <cp:lastModifiedBy>vanobber</cp:lastModifiedBy>
  <cp:revision>21</cp:revision>
  <dcterms:created xsi:type="dcterms:W3CDTF">2023-06-14T06:49:43Z</dcterms:created>
  <dcterms:modified xsi:type="dcterms:W3CDTF">2023-08-07T11:08:39Z</dcterms:modified>
</cp:coreProperties>
</file>